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6858000" cy="9906000" type="A4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2892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85728" y="238092"/>
            <a:ext cx="3071834" cy="42862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2 </a:t>
            </a:r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sepsis were eligible</a:t>
            </a:r>
            <a:endParaRPr lang="zh-CN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箭头连接符 8"/>
          <p:cNvCxnSpPr/>
          <p:nvPr/>
        </p:nvCxnSpPr>
        <p:spPr>
          <a:xfrm rot="5400000">
            <a:off x="893745" y="1558901"/>
            <a:ext cx="1785950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矩形 10"/>
          <p:cNvSpPr/>
          <p:nvPr/>
        </p:nvSpPr>
        <p:spPr>
          <a:xfrm>
            <a:off x="571480" y="2452670"/>
            <a:ext cx="2357454" cy="42862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psis patients</a:t>
            </a:r>
            <a:endParaRPr lang="zh-CN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642918" y="4310058"/>
            <a:ext cx="2357454" cy="42862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2 sepsis patients in cohort</a:t>
            </a:r>
            <a:endParaRPr lang="zh-CN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 rot="5400000">
            <a:off x="1572406" y="4952206"/>
            <a:ext cx="42862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500042" y="5167314"/>
            <a:ext cx="2786082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矩形 25"/>
          <p:cNvSpPr/>
          <p:nvPr/>
        </p:nvSpPr>
        <p:spPr>
          <a:xfrm>
            <a:off x="71414" y="5524504"/>
            <a:ext cx="1714512" cy="57150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vert DIC: </a:t>
            </a:r>
            <a:endParaRPr lang="en-US" altLang="zh-CN" sz="14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1 patients</a:t>
            </a:r>
            <a:endParaRPr lang="zh-CN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2214554" y="5524504"/>
            <a:ext cx="1714512" cy="57150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overt DIC: </a:t>
            </a:r>
            <a:endParaRPr lang="en-US" sz="14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1 </a:t>
            </a:r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endParaRPr lang="zh-CN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箭头连接符 29"/>
          <p:cNvCxnSpPr/>
          <p:nvPr/>
        </p:nvCxnSpPr>
        <p:spPr>
          <a:xfrm rot="5400000">
            <a:off x="321447" y="5345909"/>
            <a:ext cx="357984" cy="79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/>
          <p:cNvCxnSpPr/>
          <p:nvPr/>
        </p:nvCxnSpPr>
        <p:spPr>
          <a:xfrm rot="5400000">
            <a:off x="3107529" y="5345909"/>
            <a:ext cx="357984" cy="79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/>
          <p:cNvCxnSpPr/>
          <p:nvPr/>
        </p:nvCxnSpPr>
        <p:spPr>
          <a:xfrm>
            <a:off x="1785926" y="1595414"/>
            <a:ext cx="1714512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矩形 34"/>
          <p:cNvSpPr/>
          <p:nvPr/>
        </p:nvSpPr>
        <p:spPr>
          <a:xfrm>
            <a:off x="3500438" y="952472"/>
            <a:ext cx="3143272" cy="128588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 patients were excluded</a:t>
            </a:r>
            <a:endParaRPr lang="en-US" altLang="zh-CN" sz="14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  age</a:t>
            </a:r>
            <a:r>
              <a:rPr lang="zh-CN" altLang="en-US" sz="14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＜</a:t>
            </a:r>
            <a:r>
              <a:rPr lang="en-US" altLang="zh-CN" sz="14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en-US" altLang="zh-CN" sz="14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 were expected to die within 10 day</a:t>
            </a:r>
            <a:endParaRPr lang="en-US" altLang="zh-CN" sz="14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 had cancer, end stage kidney failure,             end stage liver failure, blood diseases</a:t>
            </a:r>
            <a:endParaRPr lang="en-US" altLang="zh-CN" sz="14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3500438" y="3095612"/>
            <a:ext cx="2643230" cy="10001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 patients were excluded</a:t>
            </a:r>
            <a:endParaRPr lang="en-US" altLang="zh-CN" sz="14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  died</a:t>
            </a:r>
            <a:endParaRPr lang="en-US" altLang="zh-CN" sz="14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  discharge</a:t>
            </a:r>
            <a:endParaRPr lang="en-US" altLang="zh-CN" sz="14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   protocol </a:t>
            </a:r>
            <a:r>
              <a:rPr lang="en-US" altLang="zh-CN" sz="14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olation</a:t>
            </a:r>
            <a:endParaRPr lang="en-US" altLang="zh-CN" sz="14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1428736" y="6453198"/>
            <a:ext cx="464347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1. Flow chart of the inclusion of patients </a:t>
            </a:r>
            <a:endParaRPr lang="zh-CN" altLang="en-US" dirty="0"/>
          </a:p>
        </p:txBody>
      </p:sp>
      <p:cxnSp>
        <p:nvCxnSpPr>
          <p:cNvPr id="40" name="直接箭头连接符 39"/>
          <p:cNvCxnSpPr/>
          <p:nvPr/>
        </p:nvCxnSpPr>
        <p:spPr>
          <a:xfrm>
            <a:off x="1785926" y="3595678"/>
            <a:ext cx="1714512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/>
          <p:cNvCxnSpPr/>
          <p:nvPr/>
        </p:nvCxnSpPr>
        <p:spPr>
          <a:xfrm rot="5400000">
            <a:off x="1070752" y="3594884"/>
            <a:ext cx="1428760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48648c0b-09d3-44d0-bb02-64feded649ee"/>
  <p:tag name="COMMONDATA" val="eyJoZGlkIjoiZTU1ZWVhZTA0N2FkMjY0MTkxMjMxODQ1MWIyYjEy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2</Words>
  <Application>WPS 演示</Application>
  <PresentationFormat>A4 纸张(210x297 毫米)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孟奭帅</cp:lastModifiedBy>
  <cp:revision>16</cp:revision>
  <dcterms:created xsi:type="dcterms:W3CDTF">2023-07-27T06:47:00Z</dcterms:created>
  <dcterms:modified xsi:type="dcterms:W3CDTF">2023-07-31T09:57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80891AF883C4F37A6D4332340FA4962</vt:lpwstr>
  </property>
  <property fmtid="{D5CDD505-2E9C-101B-9397-08002B2CF9AE}" pid="3" name="KSOProductBuildVer">
    <vt:lpwstr>2052-11.1.0.12313</vt:lpwstr>
  </property>
</Properties>
</file>